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801"/>
  </p:normalViewPr>
  <p:slideViewPr>
    <p:cSldViewPr snapToGrid="0" showGuides="1">
      <p:cViewPr>
        <p:scale>
          <a:sx n="94" d="100"/>
          <a:sy n="94" d="100"/>
        </p:scale>
        <p:origin x="1272" y="4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375697-83E3-6132-7047-E023327685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827A8C-DAD3-CD48-0BF7-B9E223B870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E1CFBD-4E54-7EAB-EB31-FE20334EF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03D3D-8C65-A0FB-212F-5E6402ECD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AD6A7-8CDF-CB71-60E9-DDBD8385F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210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562A6-1FAA-B505-AF84-2565B9D109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4D9F8A-A18F-DF22-00DC-40B2CA79CA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79ECA1-6C21-5BE1-0790-A0D40A991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2B451-606F-14A0-B266-3A400CAB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DFD97-DFC5-9B5B-6E2B-5807E64E6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742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681BBD-E09E-CFC7-0514-86533A5001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CDF226-1A02-023A-B5AE-9212E6938D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7A3491-96EF-77D4-6B52-E6C08355A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C6EF00-521D-2DB1-2349-CBA92B0A3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AD4AE0-775B-C7F2-805E-322C44394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490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DB181-F683-B5A3-9005-5EB7E101B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86F66A-270B-ACE7-2AB1-F4DE779B1A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52E804-404D-D16D-E1F6-71C53A5EA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648BD5-A3C9-3485-D390-498A1689E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0DE707-130C-803E-B29A-1E5AC4659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20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27D4C2-BC17-AD9F-73B0-7E7DD8F25C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C9AB7A-270B-0057-43A4-E1E7E71125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1D9514-915E-C5C2-99C8-C73F7EC2D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0DC3E9-B771-2D60-4D8C-39CFBC2BF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6AA22F-B5BD-71EF-6C9E-17243D460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980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D4074-98DD-546D-A747-9B9733781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F9793B-A16D-06AE-EC9B-B2C8665785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64F60D-6278-D68C-4445-A06165D19A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2AFACE-C6C8-3650-7CB0-86535EDE8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C05B6C-8296-6291-48EC-0157F6A92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D0FEA-D4BD-A0F1-DDA7-805C05171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899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FD8E8-51E0-03EE-B6A7-7BD10640A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1C9B3A-8E87-031C-E96A-35B4578B2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D79B72-77D2-04E3-97DF-A5B2B435B8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D910A7-CB2D-30F6-81CC-262618F671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ACC5BF-66FF-3910-14ED-E55A7C3F34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1478C4-4964-7B07-0BC9-9E97CF442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45B3F9-B1D7-8BBB-E29C-3D137629A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957401-7FF7-0DCD-D858-AED1759DD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155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02345-4B47-423F-359F-82E78AA85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8B8C87-15FE-D6D9-59A6-5F0652493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846760-D437-C176-4DA5-BD1259F58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39C51B-C0D6-8832-ABE0-6369F8283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570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D4C7CE-947C-B3AD-AD9C-E8346F5D3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DF3EE57-4D6D-F1C4-3BFF-E156996D1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85F687-CF87-533C-7D94-B9B814FE4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944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74E64-965D-428F-00BA-95481FB18B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682BCE-5E2C-74FA-8C65-85601A1D5D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947715-D4F6-494C-3D35-839D2EE51C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D49F0B-E823-DAE1-C42A-7DBD877B2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EE6D38-9A7A-9B38-E33B-D0412707A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E2A5B3-CD48-24A3-E947-373F3FD20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87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B5874-57FB-18DA-2312-9A5042F64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A696F8-355D-380A-A330-0B10BEFC29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54051-3DA9-9448-1F6B-70E747ECFC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0DCD24-18A4-D26C-585E-948120D8C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4B6BB4-0C16-746B-5E49-8D7B6B7B2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3965B0-5FCE-43B0-F16B-4ACA74DE4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431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626AA5-D0C5-14B2-39CA-324BA0E848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6BBC0D-7638-B15E-257C-35512471CA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8B06A2-5A1D-35AC-0EB6-4F2DF08E16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BA3D4-5A28-6F47-B2AB-FC8868825269}" type="datetimeFigureOut">
              <a:rPr lang="en-US" smtClean="0"/>
              <a:t>7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1CF32D-B996-C68B-8B6C-FA948C5C7F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A87778-129F-DD1E-1D51-CCB7977D1D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16E50-348A-4F47-B90A-7CC3E1712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007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61FD8BEE-4088-A329-AD85-0416F2ED43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83931" y="1458991"/>
            <a:ext cx="1279342" cy="428408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879569E-61B3-AFF1-2FE0-BE0A775976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9253" y="1778640"/>
            <a:ext cx="4541867" cy="39774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43B2CA1-08BB-A115-13FC-BA7B20DA63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2181" y="1280369"/>
            <a:ext cx="1377975" cy="42840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6435754-2EEB-1239-F928-1072D49FD5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333" y="1752638"/>
            <a:ext cx="4541867" cy="400344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8183822-08B2-2CC4-3458-AAA5C379D17C}"/>
              </a:ext>
            </a:extLst>
          </p:cNvPr>
          <p:cNvSpPr txBox="1"/>
          <p:nvPr/>
        </p:nvSpPr>
        <p:spPr>
          <a:xfrm>
            <a:off x="1560073" y="422952"/>
            <a:ext cx="22293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β oligomers solut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3379BC3-BE21-0BE0-B066-9AE0F2E066A6}"/>
              </a:ext>
            </a:extLst>
          </p:cNvPr>
          <p:cNvCxnSpPr/>
          <p:nvPr/>
        </p:nvCxnSpPr>
        <p:spPr>
          <a:xfrm>
            <a:off x="1808003" y="1232610"/>
            <a:ext cx="230830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DB230C4-21AA-F4D8-7B93-772253F0B2DB}"/>
              </a:ext>
            </a:extLst>
          </p:cNvPr>
          <p:cNvSpPr txBox="1"/>
          <p:nvPr/>
        </p:nvSpPr>
        <p:spPr>
          <a:xfrm>
            <a:off x="1729183" y="931571"/>
            <a:ext cx="4044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X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BEE891-00F0-9DE7-0013-81889B5F4DC7}"/>
              </a:ext>
            </a:extLst>
          </p:cNvPr>
          <p:cNvSpPr txBox="1"/>
          <p:nvPr/>
        </p:nvSpPr>
        <p:spPr>
          <a:xfrm rot="16200000">
            <a:off x="2329014" y="859672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1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709B69-122D-52C6-E63E-C8CC077771CF}"/>
              </a:ext>
            </a:extLst>
          </p:cNvPr>
          <p:cNvSpPr txBox="1"/>
          <p:nvPr/>
        </p:nvSpPr>
        <p:spPr>
          <a:xfrm rot="16200000">
            <a:off x="2702313" y="813472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7B10AF1-BC4D-95B6-AAEB-2F3BB989D2A5}"/>
              </a:ext>
            </a:extLst>
          </p:cNvPr>
          <p:cNvSpPr txBox="1"/>
          <p:nvPr/>
        </p:nvSpPr>
        <p:spPr>
          <a:xfrm rot="16200000">
            <a:off x="3073567" y="799916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100</a:t>
            </a:r>
          </a:p>
        </p:txBody>
      </p:sp>
      <p:sp>
        <p:nvSpPr>
          <p:cNvPr id="20" name="Trapezium 19">
            <a:extLst>
              <a:ext uri="{FF2B5EF4-FFF2-40B4-BE49-F238E27FC236}">
                <a16:creationId xmlns:a16="http://schemas.microsoft.com/office/drawing/2014/main" id="{86E09DDD-AF44-196E-B854-EC1751731BF5}"/>
              </a:ext>
            </a:extLst>
          </p:cNvPr>
          <p:cNvSpPr/>
          <p:nvPr/>
        </p:nvSpPr>
        <p:spPr>
          <a:xfrm rot="5400000">
            <a:off x="2525711" y="601988"/>
            <a:ext cx="257560" cy="1860341"/>
          </a:xfrm>
          <a:prstGeom prst="trapezoid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rapezium 21">
            <a:extLst>
              <a:ext uri="{FF2B5EF4-FFF2-40B4-BE49-F238E27FC236}">
                <a16:creationId xmlns:a16="http://schemas.microsoft.com/office/drawing/2014/main" id="{A3047C93-55DC-6F3C-93A8-CCF70253D0C5}"/>
              </a:ext>
            </a:extLst>
          </p:cNvPr>
          <p:cNvSpPr/>
          <p:nvPr/>
        </p:nvSpPr>
        <p:spPr>
          <a:xfrm rot="5400000">
            <a:off x="8383551" y="867238"/>
            <a:ext cx="317159" cy="1465921"/>
          </a:xfrm>
          <a:prstGeom prst="trapezoid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BB65A7-B6BC-6FAA-63CF-7D15ED5E6136}"/>
              </a:ext>
            </a:extLst>
          </p:cNvPr>
          <p:cNvSpPr txBox="1"/>
          <p:nvPr/>
        </p:nvSpPr>
        <p:spPr>
          <a:xfrm>
            <a:off x="7180635" y="342759"/>
            <a:ext cx="22293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β oligomers solutio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B9CB32C-6E73-E52A-8363-0AF19AEBE682}"/>
              </a:ext>
            </a:extLst>
          </p:cNvPr>
          <p:cNvCxnSpPr/>
          <p:nvPr/>
        </p:nvCxnSpPr>
        <p:spPr>
          <a:xfrm>
            <a:off x="7826639" y="1299234"/>
            <a:ext cx="230830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920FC43-404F-6363-3EC4-440C756ADE79}"/>
              </a:ext>
            </a:extLst>
          </p:cNvPr>
          <p:cNvSpPr txBox="1"/>
          <p:nvPr/>
        </p:nvSpPr>
        <p:spPr>
          <a:xfrm>
            <a:off x="7809170" y="1044336"/>
            <a:ext cx="4044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X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1A71CAD-7CE3-329D-8155-3437F1372077}"/>
              </a:ext>
            </a:extLst>
          </p:cNvPr>
          <p:cNvSpPr txBox="1"/>
          <p:nvPr/>
        </p:nvSpPr>
        <p:spPr>
          <a:xfrm rot="16200000">
            <a:off x="7992705" y="875058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1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28845D9-07F3-141F-95B2-7219B4CD4DF2}"/>
              </a:ext>
            </a:extLst>
          </p:cNvPr>
          <p:cNvSpPr txBox="1"/>
          <p:nvPr/>
        </p:nvSpPr>
        <p:spPr>
          <a:xfrm rot="16200000">
            <a:off x="8351070" y="912358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5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1D92487-E05E-E0AF-7635-2902AF71A82C}"/>
              </a:ext>
            </a:extLst>
          </p:cNvPr>
          <p:cNvSpPr txBox="1"/>
          <p:nvPr/>
        </p:nvSpPr>
        <p:spPr>
          <a:xfrm rot="16200000">
            <a:off x="8698155" y="912357"/>
            <a:ext cx="723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:10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5D17C92-4C60-C217-252E-099FF82C2D5D}"/>
              </a:ext>
            </a:extLst>
          </p:cNvPr>
          <p:cNvSpPr txBox="1"/>
          <p:nvPr/>
        </p:nvSpPr>
        <p:spPr>
          <a:xfrm>
            <a:off x="1247963" y="5899254"/>
            <a:ext cx="3784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beta</a:t>
            </a:r>
            <a:r>
              <a:rPr lang="en-US" dirty="0"/>
              <a:t> 6E10 (specific for the sequence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8206143-B386-1AF5-3652-283E940A63B3}"/>
              </a:ext>
            </a:extLst>
          </p:cNvPr>
          <p:cNvSpPr txBox="1"/>
          <p:nvPr/>
        </p:nvSpPr>
        <p:spPr>
          <a:xfrm>
            <a:off x="6906294" y="5967165"/>
            <a:ext cx="44327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11 oligomers (specific for the conformation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0280A6-EAE4-393B-72E9-DCD6F7DE127D}"/>
              </a:ext>
            </a:extLst>
          </p:cNvPr>
          <p:cNvSpPr txBox="1"/>
          <p:nvPr/>
        </p:nvSpPr>
        <p:spPr>
          <a:xfrm rot="16200000">
            <a:off x="3430663" y="635848"/>
            <a:ext cx="10148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Vehicl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FDB086-B1A0-CF38-4EE7-1A02299FD0FD}"/>
              </a:ext>
            </a:extLst>
          </p:cNvPr>
          <p:cNvSpPr txBox="1"/>
          <p:nvPr/>
        </p:nvSpPr>
        <p:spPr>
          <a:xfrm rot="16200000">
            <a:off x="9421666" y="1058224"/>
            <a:ext cx="10148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Vehicl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40D8F1-6BDB-94FC-0576-3C8A32507A29}"/>
              </a:ext>
            </a:extLst>
          </p:cNvPr>
          <p:cNvSpPr txBox="1"/>
          <p:nvPr/>
        </p:nvSpPr>
        <p:spPr>
          <a:xfrm rot="16200000">
            <a:off x="666486" y="788623"/>
            <a:ext cx="1489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ntrol peptid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8B273D-ECD9-C882-0384-27D0775D1F04}"/>
              </a:ext>
            </a:extLst>
          </p:cNvPr>
          <p:cNvSpPr txBox="1"/>
          <p:nvPr/>
        </p:nvSpPr>
        <p:spPr>
          <a:xfrm rot="16200000">
            <a:off x="8777115" y="751130"/>
            <a:ext cx="1489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ontrol peptide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5A3F764-2D10-58C3-6A46-429670B0114B}"/>
              </a:ext>
            </a:extLst>
          </p:cNvPr>
          <p:cNvCxnSpPr/>
          <p:nvPr/>
        </p:nvCxnSpPr>
        <p:spPr>
          <a:xfrm flipH="1">
            <a:off x="9695466" y="1748294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36DCD11-9596-E421-CD6F-8ED5A9504B70}"/>
              </a:ext>
            </a:extLst>
          </p:cNvPr>
          <p:cNvCxnSpPr/>
          <p:nvPr/>
        </p:nvCxnSpPr>
        <p:spPr>
          <a:xfrm flipH="1">
            <a:off x="8544712" y="1835447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05248FA-7CD0-7E1A-9AD1-49ACBFCF4FF2}"/>
              </a:ext>
            </a:extLst>
          </p:cNvPr>
          <p:cNvCxnSpPr/>
          <p:nvPr/>
        </p:nvCxnSpPr>
        <p:spPr>
          <a:xfrm flipH="1">
            <a:off x="8169215" y="1748294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8B5EB7B-A25C-091E-D306-FD9397F73BCA}"/>
              </a:ext>
            </a:extLst>
          </p:cNvPr>
          <p:cNvCxnSpPr/>
          <p:nvPr/>
        </p:nvCxnSpPr>
        <p:spPr>
          <a:xfrm flipH="1">
            <a:off x="9195270" y="1710053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DDE1076-8C5E-523E-64BF-AC46FC6CC56A}"/>
              </a:ext>
            </a:extLst>
          </p:cNvPr>
          <p:cNvCxnSpPr/>
          <p:nvPr/>
        </p:nvCxnSpPr>
        <p:spPr>
          <a:xfrm flipH="1">
            <a:off x="3558919" y="1748294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26688D7-47AA-A02D-490C-1787F250C405}"/>
              </a:ext>
            </a:extLst>
          </p:cNvPr>
          <p:cNvCxnSpPr/>
          <p:nvPr/>
        </p:nvCxnSpPr>
        <p:spPr>
          <a:xfrm flipH="1">
            <a:off x="2396337" y="1748294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E095226D-744A-DD57-B64C-45027CD3084F}"/>
              </a:ext>
            </a:extLst>
          </p:cNvPr>
          <p:cNvCxnSpPr/>
          <p:nvPr/>
        </p:nvCxnSpPr>
        <p:spPr>
          <a:xfrm flipH="1">
            <a:off x="2821852" y="1686646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FF2E89AC-95C1-681C-8670-902EA6DF83C0}"/>
              </a:ext>
            </a:extLst>
          </p:cNvPr>
          <p:cNvCxnSpPr/>
          <p:nvPr/>
        </p:nvCxnSpPr>
        <p:spPr>
          <a:xfrm flipH="1">
            <a:off x="1660250" y="1704880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2597837-7140-448E-1150-F023FFE9E24E}"/>
              </a:ext>
            </a:extLst>
          </p:cNvPr>
          <p:cNvCxnSpPr/>
          <p:nvPr/>
        </p:nvCxnSpPr>
        <p:spPr>
          <a:xfrm flipH="1">
            <a:off x="1237838" y="1686646"/>
            <a:ext cx="33737" cy="399478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07532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36</Words>
  <Application>Microsoft Macintosh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Sepe</dc:creator>
  <cp:lastModifiedBy>Sara Sepe</cp:lastModifiedBy>
  <cp:revision>4</cp:revision>
  <dcterms:created xsi:type="dcterms:W3CDTF">2025-03-31T11:24:18Z</dcterms:created>
  <dcterms:modified xsi:type="dcterms:W3CDTF">2025-07-01T20:18:51Z</dcterms:modified>
</cp:coreProperties>
</file>